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E82D250B-9DC9-49A3-92B3-1C8E085491B4}"/>
    <pc:docChg chg="undo custSel addSld delSld modSld">
      <pc:chgData name="Madhuravasal Krishnan, Janani (jananimk)" userId="6969b20d-d298-4095-ade9-5a3c5ff7904a" providerId="ADAL" clId="{E82D250B-9DC9-49A3-92B3-1C8E085491B4}" dt="2024-06-12T20:10:55.638" v="25" actId="20577"/>
      <pc:docMkLst>
        <pc:docMk/>
      </pc:docMkLst>
      <pc:sldChg chg="modSp add">
        <pc:chgData name="Madhuravasal Krishnan, Janani (jananimk)" userId="6969b20d-d298-4095-ade9-5a3c5ff7904a" providerId="ADAL" clId="{E82D250B-9DC9-49A3-92B3-1C8E085491B4}" dt="2024-06-12T20:10:55.638" v="25" actId="20577"/>
        <pc:sldMkLst>
          <pc:docMk/>
          <pc:sldMk cId="2275220239" sldId="257"/>
        </pc:sldMkLst>
        <pc:spChg chg="mod">
          <ac:chgData name="Madhuravasal Krishnan, Janani (jananimk)" userId="6969b20d-d298-4095-ade9-5a3c5ff7904a" providerId="ADAL" clId="{E82D250B-9DC9-49A3-92B3-1C8E085491B4}" dt="2024-06-12T20:10:55.638" v="25" actId="20577"/>
          <ac:spMkLst>
            <pc:docMk/>
            <pc:sldMk cId="2275220239" sldId="257"/>
            <ac:spMk id="11" creationId="{72022066-DCC0-2585-A0E7-F206908617F9}"/>
          </ac:spMkLst>
        </pc:spChg>
      </pc:sldChg>
    </pc:docChg>
  </pc:docChgLst>
  <pc:docChgLst>
    <pc:chgData name="Madhuravasal Krishnan, Janani (jananimk)" userId="6969b20d-d298-4095-ade9-5a3c5ff7904a" providerId="ADAL" clId="{47E87263-AECC-4C61-9A49-C0BB0DF8BB15}"/>
    <pc:docChg chg="modSld">
      <pc:chgData name="Madhuravasal Krishnan, Janani (jananimk)" userId="6969b20d-d298-4095-ade9-5a3c5ff7904a" providerId="ADAL" clId="{47E87263-AECC-4C61-9A49-C0BB0DF8BB15}" dt="2024-07-11T18:26:40.389" v="27" actId="1036"/>
      <pc:docMkLst>
        <pc:docMk/>
      </pc:docMkLst>
      <pc:sldChg chg="modSp">
        <pc:chgData name="Madhuravasal Krishnan, Janani (jananimk)" userId="6969b20d-d298-4095-ade9-5a3c5ff7904a" providerId="ADAL" clId="{47E87263-AECC-4C61-9A49-C0BB0DF8BB15}" dt="2024-07-11T18:26:40.389" v="27" actId="1036"/>
        <pc:sldMkLst>
          <pc:docMk/>
          <pc:sldMk cId="2275220239" sldId="257"/>
        </pc:sldMkLst>
        <pc:spChg chg="mod">
          <ac:chgData name="Madhuravasal Krishnan, Janani (jananimk)" userId="6969b20d-d298-4095-ade9-5a3c5ff7904a" providerId="ADAL" clId="{47E87263-AECC-4C61-9A49-C0BB0DF8BB15}" dt="2024-07-11T18:25:57.672" v="3" actId="123"/>
          <ac:spMkLst>
            <pc:docMk/>
            <pc:sldMk cId="2275220239" sldId="257"/>
            <ac:spMk id="11" creationId="{72022066-DCC0-2585-A0E7-F206908617F9}"/>
          </ac:spMkLst>
        </pc:spChg>
        <pc:graphicFrameChg chg="mod">
          <ac:chgData name="Madhuravasal Krishnan, Janani (jananimk)" userId="6969b20d-d298-4095-ade9-5a3c5ff7904a" providerId="ADAL" clId="{47E87263-AECC-4C61-9A49-C0BB0DF8BB15}" dt="2024-07-11T18:26:40.389" v="27" actId="1036"/>
          <ac:graphicFrameMkLst>
            <pc:docMk/>
            <pc:sldMk cId="2275220239" sldId="257"/>
            <ac:graphicFrameMk id="7" creationId="{44FACDE0-D059-4640-A4B8-46021B8E1F1F}"/>
          </ac:graphicFrameMkLst>
        </pc:graphicFrameChg>
        <pc:graphicFrameChg chg="mod">
          <ac:chgData name="Madhuravasal Krishnan, Janani (jananimk)" userId="6969b20d-d298-4095-ade9-5a3c5ff7904a" providerId="ADAL" clId="{47E87263-AECC-4C61-9A49-C0BB0DF8BB15}" dt="2024-07-11T18:26:30.536" v="15" actId="1036"/>
          <ac:graphicFrameMkLst>
            <pc:docMk/>
            <pc:sldMk cId="2275220239" sldId="257"/>
            <ac:graphicFrameMk id="12" creationId="{D179EF37-F084-4004-823E-75A4AD2C909B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nanimk\AppData\Roaming\Microsoft\Excel\Day%203-%20p24%20ELISA%20and%20pol%20genePCR%20results%20(project%20control%2073)%20(version%202).xlsb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ELISA%20for%20Tcell%20infection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49305389209595"/>
          <c:y val="2.6444760307540355E-2"/>
          <c:w val="0.75284307680816887"/>
          <c:h val="0.536012153208642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8A3-425A-9356-9ABF87D8C9B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8A3-425A-9356-9ABF87D8C9B9}"/>
              </c:ext>
            </c:extLst>
          </c:dPt>
          <c:errBars>
            <c:errBarType val="plus"/>
            <c:errValType val="cust"/>
            <c:noEndCap val="0"/>
            <c:plus>
              <c:numRef>
                <c:f>'DAY3 PCR'!$I$51:$M$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8358269586194899E-3</c:v>
                  </c:pt>
                  <c:pt idx="2">
                    <c:v>2.0242552976435801E-2</c:v>
                  </c:pt>
                  <c:pt idx="3">
                    <c:v>0.39179134793101045</c:v>
                  </c:pt>
                </c:numCache>
              </c:numRef>
            </c:plus>
            <c:minus>
              <c:numRef>
                <c:f>'DAY3 PCR'!$I$51:$M$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8358269586194899E-3</c:v>
                  </c:pt>
                  <c:pt idx="2">
                    <c:v>2.0242552976435801E-2</c:v>
                  </c:pt>
                  <c:pt idx="3">
                    <c:v>0.391791347931010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AY3 PCR'!$I$49:$M$49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DAY3 PCR'!$I$50:$M$50</c:f>
              <c:numCache>
                <c:formatCode>General</c:formatCode>
                <c:ptCount val="5"/>
                <c:pt idx="0">
                  <c:v>0</c:v>
                </c:pt>
                <c:pt idx="1">
                  <c:v>2.8077585260811491</c:v>
                </c:pt>
                <c:pt idx="2">
                  <c:v>4.3063819213273531</c:v>
                </c:pt>
                <c:pt idx="3">
                  <c:v>1.55985480946861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8A3-425A-9356-9ABF87D8C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8654064"/>
        <c:axId val="1548653232"/>
      </c:barChart>
      <c:catAx>
        <c:axId val="15486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3232"/>
        <c:crosses val="autoZero"/>
        <c:auto val="1"/>
        <c:lblAlgn val="ctr"/>
        <c:lblOffset val="100"/>
        <c:noMultiLvlLbl val="0"/>
      </c:catAx>
      <c:valAx>
        <c:axId val="154865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4064"/>
        <c:crosses val="autoZero"/>
        <c:crossBetween val="between"/>
        <c:majorUnit val="1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0253718285214"/>
          <c:y val="5.6632040994351991E-2"/>
          <c:w val="0.76982648002333043"/>
          <c:h val="0.477621515815590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1]Day 7 P24 ELISA'!$H$5:$H$8</c:f>
                <c:numCache>
                  <c:formatCode>General</c:formatCode>
                  <c:ptCount val="4"/>
                  <c:pt idx="0">
                    <c:v>2.0496371026112268</c:v>
                  </c:pt>
                  <c:pt idx="1">
                    <c:v>0.18633064569193222</c:v>
                  </c:pt>
                  <c:pt idx="2">
                    <c:v>1.1179838741515782</c:v>
                  </c:pt>
                  <c:pt idx="3">
                    <c:v>1.3043145198435104</c:v>
                  </c:pt>
                </c:numCache>
              </c:numRef>
            </c:plus>
            <c:minus>
              <c:numRef>
                <c:f>'[1]Day 7 P24 ELISA'!$H$5:$H$8</c:f>
                <c:numCache>
                  <c:formatCode>General</c:formatCode>
                  <c:ptCount val="4"/>
                  <c:pt idx="0">
                    <c:v>2.0496371026112268</c:v>
                  </c:pt>
                  <c:pt idx="1">
                    <c:v>0.18633064569193222</c:v>
                  </c:pt>
                  <c:pt idx="2">
                    <c:v>1.1179838741515782</c:v>
                  </c:pt>
                  <c:pt idx="3">
                    <c:v>1.3043145198435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]DAY3 P24 ELISA'!$B$35:$B$38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[1]Day 7 P24 ELISA'!$G$5:$G$8</c:f>
              <c:numCache>
                <c:formatCode>General</c:formatCode>
                <c:ptCount val="4"/>
                <c:pt idx="0">
                  <c:v>8.5333184930312154</c:v>
                </c:pt>
                <c:pt idx="1">
                  <c:v>33.039871831794656</c:v>
                </c:pt>
                <c:pt idx="2">
                  <c:v>61.89436205324192</c:v>
                </c:pt>
                <c:pt idx="3">
                  <c:v>35.411473767804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4A-45B2-9666-AB60803A76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243983"/>
        <c:axId val="1884350575"/>
      </c:barChart>
      <c:catAx>
        <c:axId val="141243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84350575"/>
        <c:crosses val="autoZero"/>
        <c:auto val="1"/>
        <c:lblAlgn val="ctr"/>
        <c:lblOffset val="100"/>
        <c:noMultiLvlLbl val="0"/>
      </c:catAx>
      <c:valAx>
        <c:axId val="18843505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24398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745</cdr:x>
      <cdr:y>0.07452</cdr:y>
    </cdr:from>
    <cdr:to>
      <cdr:x>0.1168</cdr:x>
      <cdr:y>0.71646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A2B07ED-FEB2-0D3D-168F-4DB68F46D945}"/>
            </a:ext>
          </a:extLst>
        </cdr:cNvPr>
        <cdr:cNvSpPr txBox="1"/>
      </cdr:nvSpPr>
      <cdr:spPr>
        <a:xfrm xmlns:a="http://schemas.openxmlformats.org/drawingml/2006/main" rot="16200000">
          <a:off x="-654037" y="988104"/>
          <a:ext cx="2048595" cy="5480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DNA proviral load</a:t>
          </a:r>
        </a:p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(log copies / 1 × 10</a:t>
          </a:r>
          <a:r>
            <a:rPr 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cells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9073</cdr:x>
      <cdr:y>0</cdr:y>
    </cdr:from>
    <cdr:to>
      <cdr:x>0.14281</cdr:x>
      <cdr:y>0.7356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865C1D8-282D-4780-8A65-FCD40EC6FDA9}"/>
            </a:ext>
          </a:extLst>
        </cdr:cNvPr>
        <cdr:cNvSpPr txBox="1"/>
      </cdr:nvSpPr>
      <cdr:spPr>
        <a:xfrm xmlns:a="http://schemas.openxmlformats.org/drawingml/2006/main" rot="16200000">
          <a:off x="-654681" y="320587"/>
          <a:ext cx="2616078" cy="2913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i="0" baseline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IV p24 (</a:t>
          </a:r>
          <a:r>
            <a:rPr lang="en-US" sz="1200" b="0" i="0" baseline="0" dirty="0" err="1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g</a:t>
          </a:r>
          <a:r>
            <a:rPr lang="en-US" sz="1200" b="0" i="0" baseline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/mL)</a:t>
          </a:r>
          <a:endParaRPr lang="en-US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01786-B61B-46FB-B88B-2F376C302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501486-2457-4E5B-A5CE-FADC175FCB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46248-AE25-4EB7-ADDB-03D64EA7F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8648D-EA7F-4005-BE15-074E93A9E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844C96-A1C6-4C7E-805C-BDB80A2CD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318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7BA09-3D50-4BEB-8C04-EED70C50D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D00B57-5F72-4464-9934-E400D54DF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E5058-27F6-4B7B-8F61-8D6F8304E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20EA8D-CF48-4525-8250-185F5A69D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A2F2C-7651-429E-AD05-0C63BAD2C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190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B3FFB6-8F3A-4DC3-9E62-2A3EC0EE55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544CCC-AFC1-48D1-B5A8-D08BF607E5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429F53-7B0F-4C99-9BED-65FB2BBE2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6DF0E2-6881-4BCA-9A4C-10F2F5CD7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2CF237-2BAB-412D-BC70-F60ACD165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52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555CF-5DB9-4F0A-A3C7-8B8CBE100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30142F-CF63-49C8-8C81-326D1F19B1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21835-F1A7-4720-8977-F14B525C5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6CD849-92A6-4E5A-9F58-E756895DA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886A98-A517-46F3-BDBB-F99D4B763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259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3E253-4F79-4B62-9632-6CC25D8619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9BD847-2A18-4FC2-AD99-E60BA9950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14F71-206E-4E47-BAC3-A9CC9794F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231262-B240-4489-A41D-9A5164BE6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CF10E1-D2E6-41C3-B56A-49AAE7BE8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5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DD20F-AA49-435C-9B48-6356CC165E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6E457-1370-4CDC-BD05-77B66F4A1F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068835-BDED-4F5A-9C3D-0EFB65432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A0CCEF-1CA2-4F57-8347-02DBF7112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5779C0-515A-4379-B6A0-1E2B027C7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67EFD2-2FF3-4BDC-823E-904493D68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884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98C87-4474-4867-B2C2-38EB9A568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1D3771-C594-4699-B7BC-FA771F3026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94DB14-20EB-4D5A-BA9B-10BE4E53BB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300145-8C51-43B0-AC21-0142C827C2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20356A-4E6E-4BC9-BA8A-4F0A2CD7DF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437640-10CC-4B01-8FB9-7EF086147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1179F5-9265-4798-AA38-4577DBD46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98E72A-6707-4390-9866-C554DB60B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102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69D10-55D2-4695-AF94-C5C639F3C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667928-096E-4A89-AF56-FE1B908D0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BF7D1F-3B6A-47D9-924F-43DDD4785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B13AD5-8F66-450F-8377-EFEB15325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34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1C4790-0DA5-4EEF-8ACB-E0424BC3E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BA23EE-4447-4BAD-9EAA-3A746196F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0A4DB4-5984-4028-9228-F6981389D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870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3D213-6776-42E8-99F5-49A65E8D8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E80680-AC4B-44D4-9B90-934E381BA6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E55866-73B2-4BA1-A1F1-7B286645B7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0F4FDB-1E4E-4FCF-9243-BF5432D99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6B38F-B3DA-48CB-8942-F11FA86B8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E93A1E-8DC9-4DE9-A0AB-4151C872B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576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7558D-2D4C-495C-A205-B6550FBDC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C39AD5-F6F2-4029-B6F0-0B2930DE2A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D15BDE-A24C-4B08-9110-BE30945C0A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F2DF27-BB56-461C-8D5F-5B8DC3B68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CD5DC5-7ECC-4FC4-AF91-517E268B2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14205-F211-4009-B531-AB46146B5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219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67C2C5-60D2-43E6-9256-D0A3E87E3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CAC488-6DDA-4A15-A627-DFA1150F44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EF4D44-61F7-42BC-BFB0-DF598140DC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F1A4-DF02-439A-9151-7ED592A30C9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B2832-1511-43ED-B464-942D95E045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0F0D9B-9D65-45F5-8BB8-D6D2A65CF2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843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D179EF37-F084-4004-823E-75A4AD2C90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2271507"/>
              </p:ext>
            </p:extLst>
          </p:nvPr>
        </p:nvGraphicFramePr>
        <p:xfrm>
          <a:off x="497585" y="1570007"/>
          <a:ext cx="5516119" cy="33170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72022066-DCC0-2585-A0E7-F206908617F9}"/>
              </a:ext>
            </a:extLst>
          </p:cNvPr>
          <p:cNvSpPr txBox="1"/>
          <p:nvPr/>
        </p:nvSpPr>
        <p:spPr>
          <a:xfrm>
            <a:off x="0" y="5849838"/>
            <a:ext cx="12192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1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BMC derived </a:t>
            </a:r>
            <a:r>
              <a:rPr lang="en-US" sz="1200" dirty="0">
                <a:latin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 cells were seeded at ~1 × 10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per well. 10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of naltrexone was added into the respective well and the cells are incubated for 24 hrs. After incubation cells were infected with HIV</a:t>
            </a:r>
            <a:r>
              <a:rPr lang="en-US" sz="105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L4-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at MOI of 1 for 2 hours and rinsed with RPMI + 10% FBS + 1% antibiotics (Pen/Strep) + 1% glutamine for three times to remove any unbound virus and replaced with fresh media. Fentanyl at concentration of 10ug/mL was added to the respective well and incubated. After incubation with drug and virus for 72 hours, HIV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oviral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NA was quantified in cells by real-time PCR based on SYBR Green I detection and HIV p24 antigen expression was estimated from the cell culture supernatant. Error bar represents the standard deviations between the replicat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4FACDE0-D059-4640-A4B8-46021B8E1F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7474053"/>
              </p:ext>
            </p:extLst>
          </p:nvPr>
        </p:nvGraphicFramePr>
        <p:xfrm>
          <a:off x="5857597" y="1414730"/>
          <a:ext cx="5595056" cy="3778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2A45B09-3869-452E-875E-78D2F0785494}"/>
              </a:ext>
            </a:extLst>
          </p:cNvPr>
          <p:cNvSpPr txBox="1"/>
          <p:nvPr/>
        </p:nvSpPr>
        <p:spPr>
          <a:xfrm>
            <a:off x="10774393" y="73696"/>
            <a:ext cx="11645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ntrol ID : 73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275220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1</cp:revision>
  <dcterms:created xsi:type="dcterms:W3CDTF">2024-06-12T20:04:34Z</dcterms:created>
  <dcterms:modified xsi:type="dcterms:W3CDTF">2024-07-11T18:26:45Z</dcterms:modified>
</cp:coreProperties>
</file>